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0" r:id="rId5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376B55E-9BC3-4E50-8AFC-3FE2A48A49B2}" v="1" dt="2024-02-27T03:15:13.22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100" autoAdjust="0"/>
  </p:normalViewPr>
  <p:slideViewPr>
    <p:cSldViewPr snapToGrid="0">
      <p:cViewPr varScale="1">
        <p:scale>
          <a:sx n="121" d="100"/>
          <a:sy n="121" d="100"/>
        </p:scale>
        <p:origin x="1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ndoza Valderrey, Alberto" userId="3ca0a5ef-cfc6-4d76-a1eb-aa1d46514f4a" providerId="ADAL" clId="{F376B55E-9BC3-4E50-8AFC-3FE2A48A49B2}"/>
    <pc:docChg chg="modSld">
      <pc:chgData name="Mendoza Valderrey, Alberto" userId="3ca0a5ef-cfc6-4d76-a1eb-aa1d46514f4a" providerId="ADAL" clId="{F376B55E-9BC3-4E50-8AFC-3FE2A48A49B2}" dt="2024-02-29T18:51:43.320" v="5" actId="1036"/>
      <pc:docMkLst>
        <pc:docMk/>
      </pc:docMkLst>
      <pc:sldChg chg="addSp modSp mod">
        <pc:chgData name="Mendoza Valderrey, Alberto" userId="3ca0a5ef-cfc6-4d76-a1eb-aa1d46514f4a" providerId="ADAL" clId="{F376B55E-9BC3-4E50-8AFC-3FE2A48A49B2}" dt="2024-02-29T18:51:43.320" v="5" actId="1036"/>
        <pc:sldMkLst>
          <pc:docMk/>
          <pc:sldMk cId="2170413701" sldId="260"/>
        </pc:sldMkLst>
        <pc:spChg chg="mod">
          <ac:chgData name="Mendoza Valderrey, Alberto" userId="3ca0a5ef-cfc6-4d76-a1eb-aa1d46514f4a" providerId="ADAL" clId="{F376B55E-9BC3-4E50-8AFC-3FE2A48A49B2}" dt="2024-02-29T18:51:43.320" v="5" actId="1036"/>
          <ac:spMkLst>
            <pc:docMk/>
            <pc:sldMk cId="2170413701" sldId="260"/>
            <ac:spMk id="6" creationId="{C349BC95-DDC7-C175-9FEA-C8DF6DE8BCAB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7" creationId="{6554E433-4FBF-8FB6-D9F6-2248EC6C270D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8" creationId="{61F32F78-3601-CC7B-E3A2-8C94FCEE8527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9" creationId="{DFA81BAA-B2C6-24C3-BBEA-94C8D3225080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10" creationId="{26E062C9-E848-6D96-BD77-13F35F145DA6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11" creationId="{8996C243-3E7F-EA31-E6A8-B6F6384C1466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12" creationId="{F1DBD629-0E25-5E24-6465-F0E1F3171243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13" creationId="{BB6C64EA-962E-E295-2C85-5AC7743C3952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14" creationId="{656BCF3A-4CA3-FECC-50CE-ADE5E48952C0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15" creationId="{7A46F558-B323-61E8-F0FE-D45790717F4A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16" creationId="{77C280EF-7A9B-03EB-C54F-1D32844FFD07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17" creationId="{3BD40980-2671-8BD2-08B2-A15D0C469CEC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18" creationId="{DCE0A503-61CA-95DF-F2B8-A0321B9A3EFC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19" creationId="{DB449291-17BC-8701-0D67-083D7C0472BE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20" creationId="{4C735E20-A247-C64D-7D1E-F0354358483D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21" creationId="{F79D2C4A-D859-51FD-A037-CA9B4486B143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22" creationId="{6E27DA76-0CCC-3395-E7ED-B28C3B998033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25" creationId="{AFD8AD88-C25A-359E-AE66-D95E1FB21C2D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28" creationId="{16E03F74-5950-8FAA-5D88-1056011902F8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29" creationId="{F91BCE83-2790-1535-B8E4-71767D3D6E29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30" creationId="{DE2F3945-20CC-CE22-E842-969ADA9AFE73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46" creationId="{145A4677-44F3-69A0-7A63-E298F16E9AA1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47" creationId="{03E39D6B-CA02-897B-CF6B-EDD7A74B0E80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48" creationId="{384584D3-D405-0657-3D02-F5F688AEC99C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49" creationId="{5ED2A967-3EDA-A8D2-18FD-A4BA9A2B97F1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50" creationId="{35C9FD1B-C806-30C8-2FF3-6AC463162571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51" creationId="{C762C516-282C-2392-7897-437450963607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52" creationId="{6459AD02-5C42-A692-15A7-0D491A7085C0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53" creationId="{D2C946FF-8B02-7817-0551-A02B0165DC51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54" creationId="{5573E4BE-0CD9-E556-3610-8416530DB058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55" creationId="{62BBFF18-AF68-2836-11E4-A99B6DBCB971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56" creationId="{47FCF99F-44CF-79A4-B92E-1AE5887778B0}"/>
          </ac:spMkLst>
        </pc:spChg>
        <pc:spChg chg="mod">
          <ac:chgData name="Mendoza Valderrey, Alberto" userId="3ca0a5ef-cfc6-4d76-a1eb-aa1d46514f4a" providerId="ADAL" clId="{F376B55E-9BC3-4E50-8AFC-3FE2A48A49B2}" dt="2024-02-27T03:15:13.229" v="0" actId="164"/>
          <ac:spMkLst>
            <pc:docMk/>
            <pc:sldMk cId="2170413701" sldId="260"/>
            <ac:spMk id="57" creationId="{60B573E8-3380-547A-29CA-63EB6D01B99A}"/>
          </ac:spMkLst>
        </pc:spChg>
        <pc:grpChg chg="add mod">
          <ac:chgData name="Mendoza Valderrey, Alberto" userId="3ca0a5ef-cfc6-4d76-a1eb-aa1d46514f4a" providerId="ADAL" clId="{F376B55E-9BC3-4E50-8AFC-3FE2A48A49B2}" dt="2024-02-27T03:15:13.229" v="0" actId="164"/>
          <ac:grpSpMkLst>
            <pc:docMk/>
            <pc:sldMk cId="2170413701" sldId="260"/>
            <ac:grpSpMk id="5" creationId="{E05107C1-5555-3452-00D5-FB473AC9905C}"/>
          </ac:grpSpMkLst>
        </pc:grpChg>
        <pc:grpChg chg="mod">
          <ac:chgData name="Mendoza Valderrey, Alberto" userId="3ca0a5ef-cfc6-4d76-a1eb-aa1d46514f4a" providerId="ADAL" clId="{F376B55E-9BC3-4E50-8AFC-3FE2A48A49B2}" dt="2024-02-27T03:15:13.229" v="0" actId="164"/>
          <ac:grpSpMkLst>
            <pc:docMk/>
            <pc:sldMk cId="2170413701" sldId="260"/>
            <ac:grpSpMk id="31" creationId="{AA83313A-9770-DB5A-B74A-DC1C8D644A91}"/>
          </ac:grpSpMkLst>
        </pc:grpChg>
        <pc:grpChg chg="mod">
          <ac:chgData name="Mendoza Valderrey, Alberto" userId="3ca0a5ef-cfc6-4d76-a1eb-aa1d46514f4a" providerId="ADAL" clId="{F376B55E-9BC3-4E50-8AFC-3FE2A48A49B2}" dt="2024-02-27T03:15:13.229" v="0" actId="164"/>
          <ac:grpSpMkLst>
            <pc:docMk/>
            <pc:sldMk cId="2170413701" sldId="260"/>
            <ac:grpSpMk id="36" creationId="{6DDA258B-2C33-8EFC-3E7E-4F808B5F0289}"/>
          </ac:grpSpMkLst>
        </pc:grpChg>
        <pc:grpChg chg="mod">
          <ac:chgData name="Mendoza Valderrey, Alberto" userId="3ca0a5ef-cfc6-4d76-a1eb-aa1d46514f4a" providerId="ADAL" clId="{F376B55E-9BC3-4E50-8AFC-3FE2A48A49B2}" dt="2024-02-27T03:15:13.229" v="0" actId="164"/>
          <ac:grpSpMkLst>
            <pc:docMk/>
            <pc:sldMk cId="2170413701" sldId="260"/>
            <ac:grpSpMk id="41" creationId="{589B7688-538A-6075-E174-950B92BFFA97}"/>
          </ac:grpSpMkLst>
        </pc:grpChg>
        <pc:picChg chg="mod">
          <ac:chgData name="Mendoza Valderrey, Alberto" userId="3ca0a5ef-cfc6-4d76-a1eb-aa1d46514f4a" providerId="ADAL" clId="{F376B55E-9BC3-4E50-8AFC-3FE2A48A49B2}" dt="2024-02-27T03:15:13.229" v="0" actId="164"/>
          <ac:picMkLst>
            <pc:docMk/>
            <pc:sldMk cId="2170413701" sldId="260"/>
            <ac:picMk id="2" creationId="{543F3F52-4011-AFFE-B4F9-C4D203BC051C}"/>
          </ac:picMkLst>
        </pc:picChg>
        <pc:picChg chg="mod">
          <ac:chgData name="Mendoza Valderrey, Alberto" userId="3ca0a5ef-cfc6-4d76-a1eb-aa1d46514f4a" providerId="ADAL" clId="{F376B55E-9BC3-4E50-8AFC-3FE2A48A49B2}" dt="2024-02-27T03:15:13.229" v="0" actId="164"/>
          <ac:picMkLst>
            <pc:docMk/>
            <pc:sldMk cId="2170413701" sldId="260"/>
            <ac:picMk id="3" creationId="{5BC2401B-D2EB-2B90-E809-3AF14D2E3D6D}"/>
          </ac:picMkLst>
        </pc:picChg>
        <pc:picChg chg="mod">
          <ac:chgData name="Mendoza Valderrey, Alberto" userId="3ca0a5ef-cfc6-4d76-a1eb-aa1d46514f4a" providerId="ADAL" clId="{F376B55E-9BC3-4E50-8AFC-3FE2A48A49B2}" dt="2024-02-27T03:15:13.229" v="0" actId="164"/>
          <ac:picMkLst>
            <pc:docMk/>
            <pc:sldMk cId="2170413701" sldId="260"/>
            <ac:picMk id="4" creationId="{287B96D5-68B1-1C4B-572C-AA4F5624DB13}"/>
          </ac:picMkLst>
        </pc:picChg>
      </pc:sldChg>
    </pc:docChg>
  </pc:docChgLst>
  <pc:docChgLst>
    <pc:chgData name="Mendoza Valderrey, Alberto" userId="3ca0a5ef-cfc6-4d76-a1eb-aa1d46514f4a" providerId="ADAL" clId="{68E814EA-B0DE-4CBC-B1EA-CA7A8E74D617}"/>
    <pc:docChg chg="undo custSel addSld delSld modSld">
      <pc:chgData name="Mendoza Valderrey, Alberto" userId="3ca0a5ef-cfc6-4d76-a1eb-aa1d46514f4a" providerId="ADAL" clId="{68E814EA-B0DE-4CBC-B1EA-CA7A8E74D617}" dt="2024-02-06T00:39:32.564" v="531" actId="47"/>
      <pc:docMkLst>
        <pc:docMk/>
      </pc:docMkLst>
      <pc:sldChg chg="addSp delSp modSp new del mod">
        <pc:chgData name="Mendoza Valderrey, Alberto" userId="3ca0a5ef-cfc6-4d76-a1eb-aa1d46514f4a" providerId="ADAL" clId="{68E814EA-B0DE-4CBC-B1EA-CA7A8E74D617}" dt="2024-02-06T00:06:08.359" v="350" actId="47"/>
        <pc:sldMkLst>
          <pc:docMk/>
          <pc:sldMk cId="1535013519" sldId="256"/>
        </pc:sldMkLst>
        <pc:spChg chg="del">
          <ac:chgData name="Mendoza Valderrey, Alberto" userId="3ca0a5ef-cfc6-4d76-a1eb-aa1d46514f4a" providerId="ADAL" clId="{68E814EA-B0DE-4CBC-B1EA-CA7A8E74D617}" dt="2024-02-01T22:54:36.973" v="1" actId="478"/>
          <ac:spMkLst>
            <pc:docMk/>
            <pc:sldMk cId="1535013519" sldId="256"/>
            <ac:spMk id="2" creationId="{432BA3FC-752C-9EC6-D533-E6629461C34D}"/>
          </ac:spMkLst>
        </pc:spChg>
        <pc:spChg chg="del">
          <ac:chgData name="Mendoza Valderrey, Alberto" userId="3ca0a5ef-cfc6-4d76-a1eb-aa1d46514f4a" providerId="ADAL" clId="{68E814EA-B0DE-4CBC-B1EA-CA7A8E74D617}" dt="2024-02-01T22:54:37.948" v="2" actId="478"/>
          <ac:spMkLst>
            <pc:docMk/>
            <pc:sldMk cId="1535013519" sldId="256"/>
            <ac:spMk id="3" creationId="{C65A5502-5E1C-53B4-A4FD-0C04F86BDC84}"/>
          </ac:spMkLst>
        </pc:spChg>
        <pc:graphicFrameChg chg="add mod">
          <ac:chgData name="Mendoza Valderrey, Alberto" userId="3ca0a5ef-cfc6-4d76-a1eb-aa1d46514f4a" providerId="ADAL" clId="{68E814EA-B0DE-4CBC-B1EA-CA7A8E74D617}" dt="2024-02-05T23:59:15.403" v="348" actId="14100"/>
          <ac:graphicFrameMkLst>
            <pc:docMk/>
            <pc:sldMk cId="1535013519" sldId="256"/>
            <ac:graphicFrameMk id="4" creationId="{FDDA9FA7-2854-D1F6-DD48-CC1D022B0355}"/>
          </ac:graphicFrameMkLst>
        </pc:graphicFrameChg>
        <pc:graphicFrameChg chg="add mod">
          <ac:chgData name="Mendoza Valderrey, Alberto" userId="3ca0a5ef-cfc6-4d76-a1eb-aa1d46514f4a" providerId="ADAL" clId="{68E814EA-B0DE-4CBC-B1EA-CA7A8E74D617}" dt="2024-02-05T23:59:17.525" v="349" actId="14100"/>
          <ac:graphicFrameMkLst>
            <pc:docMk/>
            <pc:sldMk cId="1535013519" sldId="256"/>
            <ac:graphicFrameMk id="5" creationId="{126D16AC-D42A-277B-4F13-CF13E30AD709}"/>
          </ac:graphicFrameMkLst>
        </pc:graphicFrameChg>
      </pc:sldChg>
      <pc:sldChg chg="addSp delSp modSp new mod">
        <pc:chgData name="Mendoza Valderrey, Alberto" userId="3ca0a5ef-cfc6-4d76-a1eb-aa1d46514f4a" providerId="ADAL" clId="{68E814EA-B0DE-4CBC-B1EA-CA7A8E74D617}" dt="2024-02-06T00:38:49.946" v="529" actId="2085"/>
        <pc:sldMkLst>
          <pc:docMk/>
          <pc:sldMk cId="1178151583" sldId="257"/>
        </pc:sldMkLst>
        <pc:spChg chg="del">
          <ac:chgData name="Mendoza Valderrey, Alberto" userId="3ca0a5ef-cfc6-4d76-a1eb-aa1d46514f4a" providerId="ADAL" clId="{68E814EA-B0DE-4CBC-B1EA-CA7A8E74D617}" dt="2024-02-05T19:09:00.908" v="9" actId="478"/>
          <ac:spMkLst>
            <pc:docMk/>
            <pc:sldMk cId="1178151583" sldId="257"/>
            <ac:spMk id="2" creationId="{53106EBD-B40B-ACC8-CC9D-0500709008FF}"/>
          </ac:spMkLst>
        </pc:spChg>
        <pc:spChg chg="del">
          <ac:chgData name="Mendoza Valderrey, Alberto" userId="3ca0a5ef-cfc6-4d76-a1eb-aa1d46514f4a" providerId="ADAL" clId="{68E814EA-B0DE-4CBC-B1EA-CA7A8E74D617}" dt="2024-02-05T19:09:01.744" v="10" actId="478"/>
          <ac:spMkLst>
            <pc:docMk/>
            <pc:sldMk cId="1178151583" sldId="257"/>
            <ac:spMk id="3" creationId="{BE415017-7AAD-7064-1746-ED6C15F6C6DB}"/>
          </ac:spMkLst>
        </pc:spChg>
        <pc:spChg chg="add del mod">
          <ac:chgData name="Mendoza Valderrey, Alberto" userId="3ca0a5ef-cfc6-4d76-a1eb-aa1d46514f4a" providerId="ADAL" clId="{68E814EA-B0DE-4CBC-B1EA-CA7A8E74D617}" dt="2024-02-05T21:47:52.662" v="88" actId="21"/>
          <ac:spMkLst>
            <pc:docMk/>
            <pc:sldMk cId="1178151583" sldId="257"/>
            <ac:spMk id="8" creationId="{00C5E1B4-3721-A32B-D9A0-A638161D8474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9" creationId="{D7E6D58D-4420-7019-5414-AD8FAE7CDE28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10" creationId="{5E7AEB75-254F-861A-CACB-A5A0D891BCBF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11" creationId="{159D3C85-1D39-5913-F7F6-B9B673CF52DC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12" creationId="{F46A404E-F42B-534C-B7D8-5DCDCDE586D3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13" creationId="{EB0DD298-D0DF-C767-F60E-E200AD5C6E85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14" creationId="{19CA331F-46F1-B370-052D-F715E446D413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15" creationId="{0F641C8C-41FA-D4ED-A428-B1D847B83DE3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16" creationId="{C10815C5-EC4A-06F0-4C39-EBE56D47E7E2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17" creationId="{6DCD28C2-BA12-B169-3374-6CC022FFA3EC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18" creationId="{55200529-A47C-296E-7218-6F7C9C0D1807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19" creationId="{BBDEBD0C-2D1B-146C-B797-60DC10535CD2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20" creationId="{308BED23-B21E-3A76-F673-C4A3F0F3DBD2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21" creationId="{640F9418-8C68-78BA-DC68-FDD8EE791CB5}"/>
          </ac:spMkLst>
        </pc:spChg>
        <pc:spChg chg="add del mod">
          <ac:chgData name="Mendoza Valderrey, Alberto" userId="3ca0a5ef-cfc6-4d76-a1eb-aa1d46514f4a" providerId="ADAL" clId="{68E814EA-B0DE-4CBC-B1EA-CA7A8E74D617}" dt="2024-02-06T00:35:40.582" v="441" actId="478"/>
          <ac:spMkLst>
            <pc:docMk/>
            <pc:sldMk cId="1178151583" sldId="257"/>
            <ac:spMk id="22" creationId="{13DF949D-D21E-EB07-7CBC-E99530908EA5}"/>
          </ac:spMkLst>
        </pc:spChg>
        <pc:spChg chg="add mod">
          <ac:chgData name="Mendoza Valderrey, Alberto" userId="3ca0a5ef-cfc6-4d76-a1eb-aa1d46514f4a" providerId="ADAL" clId="{68E814EA-B0DE-4CBC-B1EA-CA7A8E74D617}" dt="2024-02-05T22:27:49.632" v="340" actId="1076"/>
          <ac:spMkLst>
            <pc:docMk/>
            <pc:sldMk cId="1178151583" sldId="257"/>
            <ac:spMk id="23" creationId="{B7529C7C-602C-A3BE-D0CE-44ABF53C1D74}"/>
          </ac:spMkLst>
        </pc:spChg>
        <pc:spChg chg="add mod">
          <ac:chgData name="Mendoza Valderrey, Alberto" userId="3ca0a5ef-cfc6-4d76-a1eb-aa1d46514f4a" providerId="ADAL" clId="{68E814EA-B0DE-4CBC-B1EA-CA7A8E74D617}" dt="2024-02-05T22:27:46.129" v="339" actId="1076"/>
          <ac:spMkLst>
            <pc:docMk/>
            <pc:sldMk cId="1178151583" sldId="257"/>
            <ac:spMk id="24" creationId="{AC7B937E-9AA8-9E92-DFB2-B9A110D273D0}"/>
          </ac:spMkLst>
        </pc:spChg>
        <pc:spChg chg="add mod">
          <ac:chgData name="Mendoza Valderrey, Alberto" userId="3ca0a5ef-cfc6-4d76-a1eb-aa1d46514f4a" providerId="ADAL" clId="{68E814EA-B0DE-4CBC-B1EA-CA7A8E74D617}" dt="2024-02-05T22:27:40.596" v="338" actId="20577"/>
          <ac:spMkLst>
            <pc:docMk/>
            <pc:sldMk cId="1178151583" sldId="257"/>
            <ac:spMk id="26" creationId="{CC556A56-F7E7-628D-545C-30A9C4CC7FFC}"/>
          </ac:spMkLst>
        </pc:spChg>
        <pc:spChg chg="add mod">
          <ac:chgData name="Mendoza Valderrey, Alberto" userId="3ca0a5ef-cfc6-4d76-a1eb-aa1d46514f4a" providerId="ADAL" clId="{68E814EA-B0DE-4CBC-B1EA-CA7A8E74D617}" dt="2024-02-06T00:34:52.661" v="435" actId="1076"/>
          <ac:spMkLst>
            <pc:docMk/>
            <pc:sldMk cId="1178151583" sldId="257"/>
            <ac:spMk id="27" creationId="{FECB6B84-29D9-4AFF-2189-EFCCA5433675}"/>
          </ac:spMkLst>
        </pc:spChg>
        <pc:spChg chg="mod">
          <ac:chgData name="Mendoza Valderrey, Alberto" userId="3ca0a5ef-cfc6-4d76-a1eb-aa1d46514f4a" providerId="ADAL" clId="{68E814EA-B0DE-4CBC-B1EA-CA7A8E74D617}" dt="2024-02-06T00:38:26.901" v="524" actId="255"/>
          <ac:spMkLst>
            <pc:docMk/>
            <pc:sldMk cId="1178151583" sldId="257"/>
            <ac:spMk id="34" creationId="{73F69ADD-E8E7-46D2-3984-935425A8BC6F}"/>
          </ac:spMkLst>
        </pc:spChg>
        <pc:spChg chg="mod">
          <ac:chgData name="Mendoza Valderrey, Alberto" userId="3ca0a5ef-cfc6-4d76-a1eb-aa1d46514f4a" providerId="ADAL" clId="{68E814EA-B0DE-4CBC-B1EA-CA7A8E74D617}" dt="2024-02-06T00:38:30.838" v="525" actId="255"/>
          <ac:spMkLst>
            <pc:docMk/>
            <pc:sldMk cId="1178151583" sldId="257"/>
            <ac:spMk id="39" creationId="{C2BD53E3-D10F-1B70-1D69-0829BE52F38D}"/>
          </ac:spMkLst>
        </pc:spChg>
        <pc:spChg chg="mod">
          <ac:chgData name="Mendoza Valderrey, Alberto" userId="3ca0a5ef-cfc6-4d76-a1eb-aa1d46514f4a" providerId="ADAL" clId="{68E814EA-B0DE-4CBC-B1EA-CA7A8E74D617}" dt="2024-02-06T00:38:37.375" v="526" actId="255"/>
          <ac:spMkLst>
            <pc:docMk/>
            <pc:sldMk cId="1178151583" sldId="257"/>
            <ac:spMk id="44" creationId="{328150C2-00C1-2362-07F6-ADAC2AC1035F}"/>
          </ac:spMkLst>
        </pc:spChg>
        <pc:grpChg chg="add mod">
          <ac:chgData name="Mendoza Valderrey, Alberto" userId="3ca0a5ef-cfc6-4d76-a1eb-aa1d46514f4a" providerId="ADAL" clId="{68E814EA-B0DE-4CBC-B1EA-CA7A8E74D617}" dt="2024-02-06T00:37:48.116" v="515" actId="1076"/>
          <ac:grpSpMkLst>
            <pc:docMk/>
            <pc:sldMk cId="1178151583" sldId="257"/>
            <ac:grpSpMk id="31" creationId="{AA83313A-9770-DB5A-B74A-DC1C8D644A91}"/>
          </ac:grpSpMkLst>
        </pc:grpChg>
        <pc:grpChg chg="add mod">
          <ac:chgData name="Mendoza Valderrey, Alberto" userId="3ca0a5ef-cfc6-4d76-a1eb-aa1d46514f4a" providerId="ADAL" clId="{68E814EA-B0DE-4CBC-B1EA-CA7A8E74D617}" dt="2024-02-06T00:37:57.404" v="518" actId="14100"/>
          <ac:grpSpMkLst>
            <pc:docMk/>
            <pc:sldMk cId="1178151583" sldId="257"/>
            <ac:grpSpMk id="36" creationId="{6DDA258B-2C33-8EFC-3E7E-4F808B5F0289}"/>
          </ac:grpSpMkLst>
        </pc:grpChg>
        <pc:grpChg chg="add mod">
          <ac:chgData name="Mendoza Valderrey, Alberto" userId="3ca0a5ef-cfc6-4d76-a1eb-aa1d46514f4a" providerId="ADAL" clId="{68E814EA-B0DE-4CBC-B1EA-CA7A8E74D617}" dt="2024-02-06T00:38:18.367" v="523" actId="1076"/>
          <ac:grpSpMkLst>
            <pc:docMk/>
            <pc:sldMk cId="1178151583" sldId="257"/>
            <ac:grpSpMk id="41" creationId="{589B7688-538A-6075-E174-950B92BFFA97}"/>
          </ac:grpSpMkLst>
        </pc:grpChg>
        <pc:graphicFrameChg chg="add del mod">
          <ac:chgData name="Mendoza Valderrey, Alberto" userId="3ca0a5ef-cfc6-4d76-a1eb-aa1d46514f4a" providerId="ADAL" clId="{68E814EA-B0DE-4CBC-B1EA-CA7A8E74D617}" dt="2024-02-05T21:25:19.874" v="45"/>
          <ac:graphicFrameMkLst>
            <pc:docMk/>
            <pc:sldMk cId="1178151583" sldId="257"/>
            <ac:graphicFrameMk id="6" creationId="{EE717F21-7B46-94BF-63DC-132C2DD0457C}"/>
          </ac:graphicFrameMkLst>
        </pc:graphicFrameChg>
        <pc:picChg chg="add del mod">
          <ac:chgData name="Mendoza Valderrey, Alberto" userId="3ca0a5ef-cfc6-4d76-a1eb-aa1d46514f4a" providerId="ADAL" clId="{68E814EA-B0DE-4CBC-B1EA-CA7A8E74D617}" dt="2024-02-06T00:35:40.582" v="441" actId="478"/>
          <ac:picMkLst>
            <pc:docMk/>
            <pc:sldMk cId="1178151583" sldId="257"/>
            <ac:picMk id="4" creationId="{F4431630-66C5-F222-98CC-D55C2DF44608}"/>
          </ac:picMkLst>
        </pc:picChg>
        <pc:picChg chg="add del mod">
          <ac:chgData name="Mendoza Valderrey, Alberto" userId="3ca0a5ef-cfc6-4d76-a1eb-aa1d46514f4a" providerId="ADAL" clId="{68E814EA-B0DE-4CBC-B1EA-CA7A8E74D617}" dt="2024-02-06T00:35:40.582" v="441" actId="478"/>
          <ac:picMkLst>
            <pc:docMk/>
            <pc:sldMk cId="1178151583" sldId="257"/>
            <ac:picMk id="5" creationId="{A6467534-929B-8E8C-DD2C-F211756F1218}"/>
          </ac:picMkLst>
        </pc:picChg>
        <pc:picChg chg="add del mod">
          <ac:chgData name="Mendoza Valderrey, Alberto" userId="3ca0a5ef-cfc6-4d76-a1eb-aa1d46514f4a" providerId="ADAL" clId="{68E814EA-B0DE-4CBC-B1EA-CA7A8E74D617}" dt="2024-02-05T21:25:27.159" v="48" actId="478"/>
          <ac:picMkLst>
            <pc:docMk/>
            <pc:sldMk cId="1178151583" sldId="257"/>
            <ac:picMk id="7" creationId="{993D0B78-A455-552C-E2D9-4F0D5A2566E0}"/>
          </ac:picMkLst>
        </pc:picChg>
        <pc:picChg chg="add mod">
          <ac:chgData name="Mendoza Valderrey, Alberto" userId="3ca0a5ef-cfc6-4d76-a1eb-aa1d46514f4a" providerId="ADAL" clId="{68E814EA-B0DE-4CBC-B1EA-CA7A8E74D617}" dt="2024-02-06T00:38:46.619" v="527" actId="2085"/>
          <ac:picMkLst>
            <pc:docMk/>
            <pc:sldMk cId="1178151583" sldId="257"/>
            <ac:picMk id="28" creationId="{C2C1C3E7-2B5A-5DA3-4ACD-D82A27E1BD44}"/>
          </ac:picMkLst>
        </pc:picChg>
        <pc:picChg chg="add mod">
          <ac:chgData name="Mendoza Valderrey, Alberto" userId="3ca0a5ef-cfc6-4d76-a1eb-aa1d46514f4a" providerId="ADAL" clId="{68E814EA-B0DE-4CBC-B1EA-CA7A8E74D617}" dt="2024-02-06T00:38:48.148" v="528" actId="2085"/>
          <ac:picMkLst>
            <pc:docMk/>
            <pc:sldMk cId="1178151583" sldId="257"/>
            <ac:picMk id="29" creationId="{1BCF69A5-6B77-2973-A86A-817BF15CCB25}"/>
          </ac:picMkLst>
        </pc:picChg>
        <pc:picChg chg="add mod">
          <ac:chgData name="Mendoza Valderrey, Alberto" userId="3ca0a5ef-cfc6-4d76-a1eb-aa1d46514f4a" providerId="ADAL" clId="{68E814EA-B0DE-4CBC-B1EA-CA7A8E74D617}" dt="2024-02-06T00:38:49.946" v="529" actId="2085"/>
          <ac:picMkLst>
            <pc:docMk/>
            <pc:sldMk cId="1178151583" sldId="257"/>
            <ac:picMk id="30" creationId="{5E41BC19-25F4-D5AA-D0A2-431256BE79BF}"/>
          </ac:picMkLst>
        </pc:picChg>
        <pc:cxnChg chg="mod">
          <ac:chgData name="Mendoza Valderrey, Alberto" userId="3ca0a5ef-cfc6-4d76-a1eb-aa1d46514f4a" providerId="ADAL" clId="{68E814EA-B0DE-4CBC-B1EA-CA7A8E74D617}" dt="2024-02-06T00:37:38.943" v="512"/>
          <ac:cxnSpMkLst>
            <pc:docMk/>
            <pc:sldMk cId="1178151583" sldId="257"/>
            <ac:cxnSpMk id="32" creationId="{E7FF395F-030E-CD7D-2ED0-FDA9837363E2}"/>
          </ac:cxnSpMkLst>
        </pc:cxnChg>
        <pc:cxnChg chg="mod">
          <ac:chgData name="Mendoza Valderrey, Alberto" userId="3ca0a5ef-cfc6-4d76-a1eb-aa1d46514f4a" providerId="ADAL" clId="{68E814EA-B0DE-4CBC-B1EA-CA7A8E74D617}" dt="2024-02-06T00:37:38.943" v="512"/>
          <ac:cxnSpMkLst>
            <pc:docMk/>
            <pc:sldMk cId="1178151583" sldId="257"/>
            <ac:cxnSpMk id="33" creationId="{2EBFE943-E40D-02E0-2F46-98DEA3F45BCD}"/>
          </ac:cxnSpMkLst>
        </pc:cxnChg>
        <pc:cxnChg chg="mod">
          <ac:chgData name="Mendoza Valderrey, Alberto" userId="3ca0a5ef-cfc6-4d76-a1eb-aa1d46514f4a" providerId="ADAL" clId="{68E814EA-B0DE-4CBC-B1EA-CA7A8E74D617}" dt="2024-02-06T00:37:38.943" v="512"/>
          <ac:cxnSpMkLst>
            <pc:docMk/>
            <pc:sldMk cId="1178151583" sldId="257"/>
            <ac:cxnSpMk id="35" creationId="{06FD1DAE-11F6-5CA7-DB99-642A3C72DDF1}"/>
          </ac:cxnSpMkLst>
        </pc:cxnChg>
        <pc:cxnChg chg="mod">
          <ac:chgData name="Mendoza Valderrey, Alberto" userId="3ca0a5ef-cfc6-4d76-a1eb-aa1d46514f4a" providerId="ADAL" clId="{68E814EA-B0DE-4CBC-B1EA-CA7A8E74D617}" dt="2024-02-06T00:37:52.990" v="516"/>
          <ac:cxnSpMkLst>
            <pc:docMk/>
            <pc:sldMk cId="1178151583" sldId="257"/>
            <ac:cxnSpMk id="37" creationId="{3B8EFDCB-9FE2-1E3B-49ED-82538D557177}"/>
          </ac:cxnSpMkLst>
        </pc:cxnChg>
        <pc:cxnChg chg="mod">
          <ac:chgData name="Mendoza Valderrey, Alberto" userId="3ca0a5ef-cfc6-4d76-a1eb-aa1d46514f4a" providerId="ADAL" clId="{68E814EA-B0DE-4CBC-B1EA-CA7A8E74D617}" dt="2024-02-06T00:37:52.990" v="516"/>
          <ac:cxnSpMkLst>
            <pc:docMk/>
            <pc:sldMk cId="1178151583" sldId="257"/>
            <ac:cxnSpMk id="38" creationId="{0EEDC06D-2953-CF6F-9600-A19682285639}"/>
          </ac:cxnSpMkLst>
        </pc:cxnChg>
        <pc:cxnChg chg="mod">
          <ac:chgData name="Mendoza Valderrey, Alberto" userId="3ca0a5ef-cfc6-4d76-a1eb-aa1d46514f4a" providerId="ADAL" clId="{68E814EA-B0DE-4CBC-B1EA-CA7A8E74D617}" dt="2024-02-06T00:37:52.990" v="516"/>
          <ac:cxnSpMkLst>
            <pc:docMk/>
            <pc:sldMk cId="1178151583" sldId="257"/>
            <ac:cxnSpMk id="40" creationId="{4117065D-32B6-FDE1-8B83-ADB369DD5BB9}"/>
          </ac:cxnSpMkLst>
        </pc:cxnChg>
        <pc:cxnChg chg="mod">
          <ac:chgData name="Mendoza Valderrey, Alberto" userId="3ca0a5ef-cfc6-4d76-a1eb-aa1d46514f4a" providerId="ADAL" clId="{68E814EA-B0DE-4CBC-B1EA-CA7A8E74D617}" dt="2024-02-06T00:38:04.816" v="519"/>
          <ac:cxnSpMkLst>
            <pc:docMk/>
            <pc:sldMk cId="1178151583" sldId="257"/>
            <ac:cxnSpMk id="42" creationId="{A7E0C0F8-F3B2-AEE9-2713-34CC380CE9FA}"/>
          </ac:cxnSpMkLst>
        </pc:cxnChg>
        <pc:cxnChg chg="mod">
          <ac:chgData name="Mendoza Valderrey, Alberto" userId="3ca0a5ef-cfc6-4d76-a1eb-aa1d46514f4a" providerId="ADAL" clId="{68E814EA-B0DE-4CBC-B1EA-CA7A8E74D617}" dt="2024-02-06T00:38:04.816" v="519"/>
          <ac:cxnSpMkLst>
            <pc:docMk/>
            <pc:sldMk cId="1178151583" sldId="257"/>
            <ac:cxnSpMk id="43" creationId="{D9F378F1-9A87-D4CE-1EBB-166DC6FDB23D}"/>
          </ac:cxnSpMkLst>
        </pc:cxnChg>
        <pc:cxnChg chg="mod">
          <ac:chgData name="Mendoza Valderrey, Alberto" userId="3ca0a5ef-cfc6-4d76-a1eb-aa1d46514f4a" providerId="ADAL" clId="{68E814EA-B0DE-4CBC-B1EA-CA7A8E74D617}" dt="2024-02-06T00:38:04.816" v="519"/>
          <ac:cxnSpMkLst>
            <pc:docMk/>
            <pc:sldMk cId="1178151583" sldId="257"/>
            <ac:cxnSpMk id="45" creationId="{86C546D2-AEE2-8574-0336-C09E4BE9CAED}"/>
          </ac:cxnSpMkLst>
        </pc:cxnChg>
      </pc:sldChg>
      <pc:sldChg chg="addSp delSp modSp new del mod">
        <pc:chgData name="Mendoza Valderrey, Alberto" userId="3ca0a5ef-cfc6-4d76-a1eb-aa1d46514f4a" providerId="ADAL" clId="{68E814EA-B0DE-4CBC-B1EA-CA7A8E74D617}" dt="2024-02-06T00:39:32.564" v="531" actId="47"/>
        <pc:sldMkLst>
          <pc:docMk/>
          <pc:sldMk cId="4237957631" sldId="258"/>
        </pc:sldMkLst>
        <pc:spChg chg="del">
          <ac:chgData name="Mendoza Valderrey, Alberto" userId="3ca0a5ef-cfc6-4d76-a1eb-aa1d46514f4a" providerId="ADAL" clId="{68E814EA-B0DE-4CBC-B1EA-CA7A8E74D617}" dt="2024-02-05T19:19:48.161" v="28" actId="478"/>
          <ac:spMkLst>
            <pc:docMk/>
            <pc:sldMk cId="4237957631" sldId="258"/>
            <ac:spMk id="2" creationId="{A48F2177-FD46-0CB7-FFD1-7668A0D169A4}"/>
          </ac:spMkLst>
        </pc:spChg>
        <pc:spChg chg="del">
          <ac:chgData name="Mendoza Valderrey, Alberto" userId="3ca0a5ef-cfc6-4d76-a1eb-aa1d46514f4a" providerId="ADAL" clId="{68E814EA-B0DE-4CBC-B1EA-CA7A8E74D617}" dt="2024-02-05T19:19:50.224" v="29" actId="478"/>
          <ac:spMkLst>
            <pc:docMk/>
            <pc:sldMk cId="4237957631" sldId="258"/>
            <ac:spMk id="3" creationId="{5EE69C71-2A53-80B7-D870-88AB039FF5EE}"/>
          </ac:spMkLst>
        </pc:spChg>
        <pc:spChg chg="add mod">
          <ac:chgData name="Mendoza Valderrey, Alberto" userId="3ca0a5ef-cfc6-4d76-a1eb-aa1d46514f4a" providerId="ADAL" clId="{68E814EA-B0DE-4CBC-B1EA-CA7A8E74D617}" dt="2024-02-05T21:38:21.758" v="79" actId="1035"/>
          <ac:spMkLst>
            <pc:docMk/>
            <pc:sldMk cId="4237957631" sldId="258"/>
            <ac:spMk id="5" creationId="{387EB3F9-4327-1148-06E2-79CF16375050}"/>
          </ac:spMkLst>
        </pc:spChg>
        <pc:spChg chg="add mod">
          <ac:chgData name="Mendoza Valderrey, Alberto" userId="3ca0a5ef-cfc6-4d76-a1eb-aa1d46514f4a" providerId="ADAL" clId="{68E814EA-B0DE-4CBC-B1EA-CA7A8E74D617}" dt="2024-02-05T21:40:33.916" v="87" actId="1076"/>
          <ac:spMkLst>
            <pc:docMk/>
            <pc:sldMk cId="4237957631" sldId="258"/>
            <ac:spMk id="6" creationId="{5303E6C6-E874-0156-F24F-79281DF0E487}"/>
          </ac:spMkLst>
        </pc:spChg>
        <pc:spChg chg="add mod">
          <ac:chgData name="Mendoza Valderrey, Alberto" userId="3ca0a5ef-cfc6-4d76-a1eb-aa1d46514f4a" providerId="ADAL" clId="{68E814EA-B0DE-4CBC-B1EA-CA7A8E74D617}" dt="2024-02-05T22:01:52.142" v="163" actId="1076"/>
          <ac:spMkLst>
            <pc:docMk/>
            <pc:sldMk cId="4237957631" sldId="258"/>
            <ac:spMk id="7" creationId="{8077B040-26A6-7EF9-CC3E-D49E9D413410}"/>
          </ac:spMkLst>
        </pc:spChg>
        <pc:spChg chg="add mod">
          <ac:chgData name="Mendoza Valderrey, Alberto" userId="3ca0a5ef-cfc6-4d76-a1eb-aa1d46514f4a" providerId="ADAL" clId="{68E814EA-B0DE-4CBC-B1EA-CA7A8E74D617}" dt="2024-02-05T21:55:40.479" v="131" actId="1036"/>
          <ac:spMkLst>
            <pc:docMk/>
            <pc:sldMk cId="4237957631" sldId="258"/>
            <ac:spMk id="8" creationId="{8847C8AD-F0BA-AB9C-A708-6B04043734ED}"/>
          </ac:spMkLst>
        </pc:spChg>
        <pc:spChg chg="add del mod">
          <ac:chgData name="Mendoza Valderrey, Alberto" userId="3ca0a5ef-cfc6-4d76-a1eb-aa1d46514f4a" providerId="ADAL" clId="{68E814EA-B0DE-4CBC-B1EA-CA7A8E74D617}" dt="2024-02-05T22:00:40.015" v="162" actId="478"/>
          <ac:spMkLst>
            <pc:docMk/>
            <pc:sldMk cId="4237957631" sldId="258"/>
            <ac:spMk id="9" creationId="{B71FF28B-E6B6-EE30-D85D-9F9B99F3A2FD}"/>
          </ac:spMkLst>
        </pc:spChg>
        <pc:spChg chg="add del mod">
          <ac:chgData name="Mendoza Valderrey, Alberto" userId="3ca0a5ef-cfc6-4d76-a1eb-aa1d46514f4a" providerId="ADAL" clId="{68E814EA-B0DE-4CBC-B1EA-CA7A8E74D617}" dt="2024-02-05T22:00:01.166" v="155" actId="478"/>
          <ac:spMkLst>
            <pc:docMk/>
            <pc:sldMk cId="4237957631" sldId="258"/>
            <ac:spMk id="10" creationId="{4193C87E-054C-4FE7-FF3E-A8C8B59D0125}"/>
          </ac:spMkLst>
        </pc:spChg>
        <pc:spChg chg="add mod">
          <ac:chgData name="Mendoza Valderrey, Alberto" userId="3ca0a5ef-cfc6-4d76-a1eb-aa1d46514f4a" providerId="ADAL" clId="{68E814EA-B0DE-4CBC-B1EA-CA7A8E74D617}" dt="2024-02-05T22:00:19.660" v="161" actId="1035"/>
          <ac:spMkLst>
            <pc:docMk/>
            <pc:sldMk cId="4237957631" sldId="258"/>
            <ac:spMk id="11" creationId="{B3A79872-A2A4-5A26-C793-957173B0EB20}"/>
          </ac:spMkLst>
        </pc:spChg>
        <pc:spChg chg="add mod">
          <ac:chgData name="Mendoza Valderrey, Alberto" userId="3ca0a5ef-cfc6-4d76-a1eb-aa1d46514f4a" providerId="ADAL" clId="{68E814EA-B0DE-4CBC-B1EA-CA7A8E74D617}" dt="2024-02-05T22:04:14.694" v="174" actId="1036"/>
          <ac:spMkLst>
            <pc:docMk/>
            <pc:sldMk cId="4237957631" sldId="258"/>
            <ac:spMk id="13" creationId="{099A0E78-08FD-64BD-1858-DA917F3B3B35}"/>
          </ac:spMkLst>
        </pc:spChg>
        <pc:spChg chg="add mod">
          <ac:chgData name="Mendoza Valderrey, Alberto" userId="3ca0a5ef-cfc6-4d76-a1eb-aa1d46514f4a" providerId="ADAL" clId="{68E814EA-B0DE-4CBC-B1EA-CA7A8E74D617}" dt="2024-02-05T22:04:28.122" v="180" actId="1035"/>
          <ac:spMkLst>
            <pc:docMk/>
            <pc:sldMk cId="4237957631" sldId="258"/>
            <ac:spMk id="14" creationId="{470ADFB4-C194-C26B-D4D1-11631F4B76E0}"/>
          </ac:spMkLst>
        </pc:spChg>
        <pc:spChg chg="add mod">
          <ac:chgData name="Mendoza Valderrey, Alberto" userId="3ca0a5ef-cfc6-4d76-a1eb-aa1d46514f4a" providerId="ADAL" clId="{68E814EA-B0DE-4CBC-B1EA-CA7A8E74D617}" dt="2024-02-06T00:34:55.918" v="436"/>
          <ac:spMkLst>
            <pc:docMk/>
            <pc:sldMk cId="4237957631" sldId="258"/>
            <ac:spMk id="15" creationId="{D5B68135-B1AE-8F38-C364-00EF5760E611}"/>
          </ac:spMkLst>
        </pc:spChg>
        <pc:graphicFrameChg chg="add mod">
          <ac:chgData name="Mendoza Valderrey, Alberto" userId="3ca0a5ef-cfc6-4d76-a1eb-aa1d46514f4a" providerId="ADAL" clId="{68E814EA-B0DE-4CBC-B1EA-CA7A8E74D617}" dt="2024-02-06T00:35:55.294" v="444" actId="2085"/>
          <ac:graphicFrameMkLst>
            <pc:docMk/>
            <pc:sldMk cId="4237957631" sldId="258"/>
            <ac:graphicFrameMk id="4" creationId="{1AD22D53-4CE1-D66A-EF8F-26695EB98255}"/>
          </ac:graphicFrameMkLst>
        </pc:graphicFrameChg>
        <pc:graphicFrameChg chg="add del mod">
          <ac:chgData name="Mendoza Valderrey, Alberto" userId="3ca0a5ef-cfc6-4d76-a1eb-aa1d46514f4a" providerId="ADAL" clId="{68E814EA-B0DE-4CBC-B1EA-CA7A8E74D617}" dt="2024-02-05T22:04:02.924" v="165"/>
          <ac:graphicFrameMkLst>
            <pc:docMk/>
            <pc:sldMk cId="4237957631" sldId="258"/>
            <ac:graphicFrameMk id="12" creationId="{1B78844E-FDDF-6475-ECE0-87136659C48F}"/>
          </ac:graphicFrameMkLst>
        </pc:graphicFrameChg>
        <pc:picChg chg="add del mod">
          <ac:chgData name="Mendoza Valderrey, Alberto" userId="3ca0a5ef-cfc6-4d76-a1eb-aa1d46514f4a" providerId="ADAL" clId="{68E814EA-B0DE-4CBC-B1EA-CA7A8E74D617}" dt="2024-02-06T00:35:56.595" v="445" actId="478"/>
          <ac:picMkLst>
            <pc:docMk/>
            <pc:sldMk cId="4237957631" sldId="258"/>
            <ac:picMk id="16" creationId="{05EEE6B5-F397-E49B-CA5C-6AFA2F649301}"/>
          </ac:picMkLst>
        </pc:picChg>
      </pc:sldChg>
      <pc:sldChg chg="modSp add del mod">
        <pc:chgData name="Mendoza Valderrey, Alberto" userId="3ca0a5ef-cfc6-4d76-a1eb-aa1d46514f4a" providerId="ADAL" clId="{68E814EA-B0DE-4CBC-B1EA-CA7A8E74D617}" dt="2024-02-06T00:39:31.955" v="530" actId="47"/>
        <pc:sldMkLst>
          <pc:docMk/>
          <pc:sldMk cId="1523402862" sldId="259"/>
        </pc:sldMkLst>
        <pc:picChg chg="mod">
          <ac:chgData name="Mendoza Valderrey, Alberto" userId="3ca0a5ef-cfc6-4d76-a1eb-aa1d46514f4a" providerId="ADAL" clId="{68E814EA-B0DE-4CBC-B1EA-CA7A8E74D617}" dt="2024-02-06T00:35:50.922" v="442" actId="2085"/>
          <ac:picMkLst>
            <pc:docMk/>
            <pc:sldMk cId="1523402862" sldId="259"/>
            <ac:picMk id="4" creationId="{F4431630-66C5-F222-98CC-D55C2DF44608}"/>
          </ac:picMkLst>
        </pc:picChg>
        <pc:picChg chg="mod">
          <ac:chgData name="Mendoza Valderrey, Alberto" userId="3ca0a5ef-cfc6-4d76-a1eb-aa1d46514f4a" providerId="ADAL" clId="{68E814EA-B0DE-4CBC-B1EA-CA7A8E74D617}" dt="2024-02-06T00:35:52.387" v="443" actId="2085"/>
          <ac:picMkLst>
            <pc:docMk/>
            <pc:sldMk cId="1523402862" sldId="259"/>
            <ac:picMk id="5" creationId="{A6467534-929B-8E8C-DD2C-F211756F121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25F738-4C51-DA9F-3A60-2F329488FF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59B71C-9DD3-F3ED-1540-9124F8213D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A5FB0-59B9-2FD2-38CC-7EE235E9A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F41ADE-E173-4B9C-9AA2-3035D3C28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015C1A-3CCA-C1DD-DBBE-B7229A2D0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152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6467C-4389-98DF-604F-6C59DDDC0E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DB6303-F2EF-3C15-F0BF-B86229B9E3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11DC4A-5F19-A2D5-8666-C1585124A9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734B9C-E42E-1232-9EC1-CC3925EB3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4BA6F0-5A96-46D5-4679-16F6F4BCB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787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1AA203-31BB-69E9-5989-52A4722DA4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F0DF25-C0FD-D621-EFB1-3D535A1F2B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D788F2-A337-46BC-5FA5-61E7C192E7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FB5BDB-639C-763D-2752-0913DA8EB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AE967A-05EF-D8B7-A0E7-591B5DDB6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234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39347-5D91-FD5E-CADB-8C9B86B4C9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46E4AC-AD0F-6DC0-AE23-A13C23E117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D72BEF-6B43-0647-18A8-594DD9B85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23E50-C4A1-B4CF-A6EF-6E9CE5E62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7221FF-9327-740B-5407-2F66F2CA4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174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1C9B6-6175-5CBF-B196-0486A6B8B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354877-F333-A93A-B231-BD7657A579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B69F89-0B73-324C-FC8E-4D8A6D2FE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88A131-FCF3-BDC5-93E8-BE027561D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097D9C-C948-D564-D062-8432955FF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808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1A2ED3-D66E-7C79-16A5-73C29B73B4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C9EDD3-A5FB-9DEA-F0B4-7E395EF0A1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41DBC4-C32B-F5ED-8CB7-DE7F1CF6D2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2220DF-7242-73C7-DF76-77DA85EFB2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5A3B39-4A58-2988-32AD-B26F5143A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D0E89D-3C6E-79CC-3EED-6AF9EFE4A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873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B1F11F-3E0F-8988-7830-5D8D6B22FA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CE3FF9-04B0-0798-6B2D-48C4EEB02C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0E14C3-282C-B0E4-A3E1-4E71C64958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59A80E-01F2-B766-93C6-39F657CF26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34DFD9-80D9-D5D6-ACFB-23E1CA47C4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6B2A9D-EF32-DEA6-01ED-00DCA15EE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DB516B6-59F0-7EE6-9765-796A5B394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1AE61D-E8C2-EF77-864A-1ADEC2775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706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79A57A-AC05-AD05-EC60-2F7739F2C1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609E7E-B281-962A-F41B-2C38A3BC8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EE2F6F-FB31-C329-E36D-3867BD145D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092B10-F1E0-FD14-492A-AC2CFAFD6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77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753FE2-BA41-F208-00DB-3FE8B38DC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DCF2947-2039-67D6-AC63-19B760FBF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E1FA1D-CB3B-2484-1EE4-F34AFE571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919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12D0DC-4B70-773E-1DB9-538907A991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103747-E178-FCFF-6C36-F8E154E7D2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9E2F46-DEE8-6EA8-8F89-F74AFBA023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D06993-B103-7E25-18A2-8C795575EC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C3F736-CD0B-102C-0E8D-FBF213D8B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5776A3-456E-4DFF-F3DC-B57D956B4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409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E87C30-D0BF-B326-6B2C-CCC978DE98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F417C0-1746-0E96-A945-A962E271B2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A71AAF-F088-DE14-D0EC-9AED672639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EC54BA-7F2C-A079-A76D-A6DBA8FC0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DD1A73-E99E-0639-5B97-D5C07E3452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561360-A8F6-746F-8755-8F73F00F9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572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3BE05F-28BF-3B2E-BA9B-A487C0F12C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D3014D-BAF0-3863-4663-29B106EB19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13E1AD-E210-A4E5-8755-45635E76C6E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18D675-E4C3-437E-AA3C-539B1FBBD2E3}" type="datetimeFigureOut">
              <a:rPr lang="en-US" smtClean="0"/>
              <a:t>2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A82DB7-2D63-57AD-AFA4-63955B8ABE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C5B392-6015-D455-22F7-6861FB5CE6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815EDE-348C-4FF3-A512-A9FBCEDD87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027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E05107C1-5555-3452-00D5-FB473AC9905C}"/>
              </a:ext>
            </a:extLst>
          </p:cNvPr>
          <p:cNvGrpSpPr/>
          <p:nvPr/>
        </p:nvGrpSpPr>
        <p:grpSpPr>
          <a:xfrm>
            <a:off x="-13495" y="81926"/>
            <a:ext cx="12170326" cy="5273218"/>
            <a:chOff x="-13495" y="81926"/>
            <a:chExt cx="12170326" cy="5273218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43F3F52-4011-AFFE-B4F9-C4D203BC05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010" t="11371" r="10094" b="10591"/>
            <a:stretch/>
          </p:blipFill>
          <p:spPr>
            <a:xfrm>
              <a:off x="313126" y="780984"/>
              <a:ext cx="3844957" cy="2843916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AA83313A-9770-DB5A-B74A-DC1C8D644A91}"/>
                </a:ext>
              </a:extLst>
            </p:cNvPr>
            <p:cNvGrpSpPr/>
            <p:nvPr/>
          </p:nvGrpSpPr>
          <p:grpSpPr>
            <a:xfrm>
              <a:off x="1391062" y="640653"/>
              <a:ext cx="1651858" cy="261610"/>
              <a:chOff x="873626" y="5804545"/>
              <a:chExt cx="838218" cy="261610"/>
            </a:xfrm>
          </p:grpSpPr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E7FF395F-030E-CD7D-2ED0-FDA9837363E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74657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2EBFE943-E40D-02E0-2F46-98DEA3F45B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4570" y="6006340"/>
                <a:ext cx="837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3F69ADD-E8E7-46D2-3984-935425A8BC6F}"/>
                  </a:ext>
                </a:extLst>
              </p:cNvPr>
              <p:cNvSpPr txBox="1"/>
              <p:nvPr/>
            </p:nvSpPr>
            <p:spPr>
              <a:xfrm>
                <a:off x="873626" y="5804545"/>
                <a:ext cx="83821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i="1" dirty="0"/>
                  <a:t>P </a:t>
                </a:r>
                <a:r>
                  <a:rPr lang="en-US" sz="1100" b="1" dirty="0"/>
                  <a:t>= 0.073</a:t>
                </a:r>
              </a:p>
            </p:txBody>
          </p: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06FD1DAE-11F6-5CA7-DB99-642A3C72DDF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10485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6DDA258B-2C33-8EFC-3E7E-4F808B5F0289}"/>
                </a:ext>
              </a:extLst>
            </p:cNvPr>
            <p:cNvGrpSpPr/>
            <p:nvPr/>
          </p:nvGrpSpPr>
          <p:grpSpPr>
            <a:xfrm>
              <a:off x="5659152" y="645232"/>
              <a:ext cx="1651856" cy="261610"/>
              <a:chOff x="873626" y="5804545"/>
              <a:chExt cx="838218" cy="261610"/>
            </a:xfrm>
          </p:grpSpPr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3B8EFDCB-9FE2-1E3B-49ED-82538D55717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74657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0EEDC06D-2953-CF6F-9600-A196822856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4570" y="6006340"/>
                <a:ext cx="837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C2BD53E3-D10F-1B70-1D69-0829BE52F38D}"/>
                  </a:ext>
                </a:extLst>
              </p:cNvPr>
              <p:cNvSpPr txBox="1"/>
              <p:nvPr/>
            </p:nvSpPr>
            <p:spPr>
              <a:xfrm>
                <a:off x="873626" y="5804545"/>
                <a:ext cx="83821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i="1" dirty="0"/>
                  <a:t>P </a:t>
                </a:r>
                <a:r>
                  <a:rPr lang="en-US" sz="1100" b="1" dirty="0"/>
                  <a:t>= 0.016</a:t>
                </a:r>
              </a:p>
            </p:txBody>
          </p: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4117065D-32B6-FDE1-8B83-ADB369DD5BB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10485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589B7688-538A-6075-E174-950B92BFFA97}"/>
                </a:ext>
              </a:extLst>
            </p:cNvPr>
            <p:cNvGrpSpPr/>
            <p:nvPr/>
          </p:nvGrpSpPr>
          <p:grpSpPr>
            <a:xfrm>
              <a:off x="9535341" y="640653"/>
              <a:ext cx="1746713" cy="261610"/>
              <a:chOff x="873626" y="5804545"/>
              <a:chExt cx="838218" cy="261610"/>
            </a:xfrm>
          </p:grpSpPr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A7E0C0F8-F3B2-AEE9-2713-34CC380CE9F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74657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D9F378F1-9A87-D4CE-1EBB-166DC6FDB2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4570" y="6006340"/>
                <a:ext cx="837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28150C2-00C1-2362-07F6-ADAC2AC1035F}"/>
                  </a:ext>
                </a:extLst>
              </p:cNvPr>
              <p:cNvSpPr txBox="1"/>
              <p:nvPr/>
            </p:nvSpPr>
            <p:spPr>
              <a:xfrm>
                <a:off x="873626" y="5804545"/>
                <a:ext cx="83821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i="1" dirty="0"/>
                  <a:t>P </a:t>
                </a:r>
                <a:r>
                  <a:rPr lang="en-US" sz="1100" b="1" dirty="0"/>
                  <a:t>= 0.0008</a:t>
                </a:r>
              </a:p>
            </p:txBody>
          </p: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86C546D2-AEE2-8574-0336-C09E4BE9CAE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10485" y="6000468"/>
                <a:ext cx="1359" cy="263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BC2401B-D2EB-2B90-E809-3AF14D2E3D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4562" t="13780" r="16514" b="10033"/>
            <a:stretch/>
          </p:blipFill>
          <p:spPr>
            <a:xfrm>
              <a:off x="4466301" y="771457"/>
              <a:ext cx="3638352" cy="2865329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87B96D5-68B1-1C4B-572C-AA4F5624DB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603" t="13761" r="17293" b="9835"/>
            <a:stretch/>
          </p:blipFill>
          <p:spPr>
            <a:xfrm>
              <a:off x="8434053" y="778589"/>
              <a:ext cx="3591259" cy="2873883"/>
            </a:xfrm>
            <a:prstGeom prst="rect">
              <a:avLst/>
            </a:prstGeom>
            <a:ln>
              <a:noFill/>
            </a:ln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349BC95-DDC7-C175-9FEA-C8DF6DE8BCAB}"/>
                </a:ext>
              </a:extLst>
            </p:cNvPr>
            <p:cNvSpPr txBox="1"/>
            <p:nvPr/>
          </p:nvSpPr>
          <p:spPr>
            <a:xfrm>
              <a:off x="40470" y="81926"/>
              <a:ext cx="2826721" cy="2008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ts val="619"/>
                </a:lnSpc>
              </a:pPr>
              <a:r>
                <a:rPr lang="en-US" sz="1500" b="1" dirty="0"/>
                <a:t>Supplementary Figure 2  </a:t>
              </a:r>
              <a:endParaRPr lang="en-US" sz="15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554E433-4FBF-8FB6-D9F6-2248EC6C270D}"/>
                </a:ext>
              </a:extLst>
            </p:cNvPr>
            <p:cNvSpPr txBox="1"/>
            <p:nvPr/>
          </p:nvSpPr>
          <p:spPr>
            <a:xfrm>
              <a:off x="319507" y="4154815"/>
              <a:ext cx="11813930" cy="12003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*</a:t>
              </a:r>
              <a:r>
                <a:rPr lang="en-US" sz="1200" dirty="0"/>
                <a:t> patients </a:t>
              </a:r>
              <a:r>
                <a:rPr lang="en-US" sz="1200"/>
                <a:t>with Lung BrMs</a:t>
              </a:r>
              <a:r>
                <a:rPr lang="en-US" sz="1200" dirty="0"/>
                <a:t> receiving IO treatments within 30 days prior to craniotomy</a:t>
              </a:r>
            </a:p>
            <a:p>
              <a:r>
                <a:rPr lang="en-US" sz="1200" b="1" dirty="0"/>
                <a:t>#</a:t>
              </a:r>
              <a:r>
                <a:rPr lang="en-US" sz="1200" dirty="0"/>
                <a:t> patients with </a:t>
              </a:r>
              <a:r>
                <a:rPr lang="en-US" sz="1200" dirty="0" err="1"/>
                <a:t>BrMs</a:t>
              </a:r>
              <a:r>
                <a:rPr lang="en-US" sz="1200" dirty="0"/>
                <a:t> receiving chemotherapy within 30 days prior to craniotomy</a:t>
              </a:r>
            </a:p>
            <a:p>
              <a:r>
                <a:rPr lang="en-US" sz="1200" b="1" dirty="0"/>
                <a:t>$</a:t>
              </a:r>
              <a:r>
                <a:rPr lang="en-US" sz="1200" dirty="0"/>
                <a:t> patients with </a:t>
              </a:r>
              <a:r>
                <a:rPr lang="en-US" sz="1200" dirty="0" err="1"/>
                <a:t>BrMs</a:t>
              </a:r>
              <a:r>
                <a:rPr lang="en-US" sz="1200" dirty="0"/>
                <a:t> receiving IO treatments at any other time prior to craniotomy. IO treatments were interrupted at least 30 days prior to the collection of MBM samples.</a:t>
              </a:r>
            </a:p>
            <a:p>
              <a:endParaRPr lang="en-US" sz="1200" dirty="0"/>
            </a:p>
            <a:p>
              <a:endParaRPr lang="en-US" sz="1200" dirty="0"/>
            </a:p>
            <a:p>
              <a:endParaRPr lang="en-US" sz="12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1F32F78-3601-CC7B-E3A2-8C94FCEE8527}"/>
                </a:ext>
              </a:extLst>
            </p:cNvPr>
            <p:cNvSpPr txBox="1"/>
            <p:nvPr/>
          </p:nvSpPr>
          <p:spPr>
            <a:xfrm rot="16200000">
              <a:off x="-1290108" y="2057598"/>
              <a:ext cx="276867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b="1"/>
              </a:lvl1pPr>
            </a:lstStyle>
            <a:p>
              <a:pPr algn="ctr"/>
              <a:r>
                <a:rPr lang="en-US" sz="800" b="0" dirty="0"/>
                <a:t>% of infiltrating cell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FA81BAA-B2C6-24C3-BBEA-94C8D3225080}"/>
                </a:ext>
              </a:extLst>
            </p:cNvPr>
            <p:cNvSpPr txBox="1"/>
            <p:nvPr/>
          </p:nvSpPr>
          <p:spPr>
            <a:xfrm>
              <a:off x="313126" y="485120"/>
              <a:ext cx="384495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CD8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6E062C9-E848-6D96-BD77-13F35F145DA6}"/>
                </a:ext>
              </a:extLst>
            </p:cNvPr>
            <p:cNvSpPr txBox="1"/>
            <p:nvPr/>
          </p:nvSpPr>
          <p:spPr>
            <a:xfrm>
              <a:off x="342900" y="3680492"/>
              <a:ext cx="1181393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                                  MBM (</a:t>
              </a:r>
              <a:r>
                <a:rPr lang="en-US" sz="800" i="1" dirty="0"/>
                <a:t>n</a:t>
              </a:r>
              <a:r>
                <a:rPr lang="en-US" sz="800" dirty="0"/>
                <a:t>=13)                                          non-MBM (</a:t>
              </a:r>
              <a:r>
                <a:rPr lang="en-US" sz="800" i="1" dirty="0"/>
                <a:t>n</a:t>
              </a:r>
              <a:r>
                <a:rPr lang="en-US" sz="800" dirty="0"/>
                <a:t>=43)                                                                                         MBM (</a:t>
              </a:r>
              <a:r>
                <a:rPr lang="en-US" sz="800" i="1" dirty="0"/>
                <a:t>n</a:t>
              </a:r>
              <a:r>
                <a:rPr lang="en-US" sz="800" dirty="0"/>
                <a:t>=13)                                                non-MBM (</a:t>
              </a:r>
              <a:r>
                <a:rPr lang="en-US" sz="800" i="1" dirty="0"/>
                <a:t>n</a:t>
              </a:r>
              <a:r>
                <a:rPr lang="en-US" sz="800" dirty="0"/>
                <a:t>=41)                                                                              MBM (</a:t>
              </a:r>
              <a:r>
                <a:rPr lang="en-US" sz="800" i="1" dirty="0"/>
                <a:t>n</a:t>
              </a:r>
              <a:r>
                <a:rPr lang="en-US" sz="800" dirty="0"/>
                <a:t>=13)                                                non-MBM (</a:t>
              </a:r>
              <a:r>
                <a:rPr lang="en-US" sz="800" i="1" dirty="0"/>
                <a:t>n</a:t>
              </a:r>
              <a:r>
                <a:rPr lang="en-US" sz="800" dirty="0"/>
                <a:t>=43)                 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996C243-3E7F-EA31-E6A8-B6F6384C1466}"/>
                </a:ext>
              </a:extLst>
            </p:cNvPr>
            <p:cNvSpPr txBox="1"/>
            <p:nvPr/>
          </p:nvSpPr>
          <p:spPr>
            <a:xfrm>
              <a:off x="4465021" y="476728"/>
              <a:ext cx="363835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CD2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1DBD629-0E25-5E24-6465-F0E1F3171243}"/>
                </a:ext>
              </a:extLst>
            </p:cNvPr>
            <p:cNvSpPr txBox="1"/>
            <p:nvPr/>
          </p:nvSpPr>
          <p:spPr>
            <a:xfrm>
              <a:off x="8435096" y="491164"/>
              <a:ext cx="358917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S100 surrounding tumor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B6C64EA-962E-E295-2C85-5AC7743C3952}"/>
                </a:ext>
              </a:extLst>
            </p:cNvPr>
            <p:cNvSpPr txBox="1"/>
            <p:nvPr/>
          </p:nvSpPr>
          <p:spPr>
            <a:xfrm>
              <a:off x="111966" y="957980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8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56BCF3A-4CA3-FECC-50CE-ADE5E48952C0}"/>
                </a:ext>
              </a:extLst>
            </p:cNvPr>
            <p:cNvSpPr txBox="1"/>
            <p:nvPr/>
          </p:nvSpPr>
          <p:spPr>
            <a:xfrm>
              <a:off x="111966" y="1269424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6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A46F558-B323-61E8-F0FE-D45790717F4A}"/>
                </a:ext>
              </a:extLst>
            </p:cNvPr>
            <p:cNvSpPr txBox="1"/>
            <p:nvPr/>
          </p:nvSpPr>
          <p:spPr>
            <a:xfrm>
              <a:off x="111965" y="1581141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4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7C280EF-7A9B-03EB-C54F-1D32844FFD07}"/>
                </a:ext>
              </a:extLst>
            </p:cNvPr>
            <p:cNvSpPr txBox="1"/>
            <p:nvPr/>
          </p:nvSpPr>
          <p:spPr>
            <a:xfrm>
              <a:off x="111965" y="1885063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2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BD40980-2671-8BD2-08B2-A15D0C469CEC}"/>
                </a:ext>
              </a:extLst>
            </p:cNvPr>
            <p:cNvSpPr txBox="1"/>
            <p:nvPr/>
          </p:nvSpPr>
          <p:spPr>
            <a:xfrm>
              <a:off x="169462" y="2348542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/>
                <a:t>6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CE0A503-61CA-95DF-F2B8-A0321B9A3EFC}"/>
                </a:ext>
              </a:extLst>
            </p:cNvPr>
            <p:cNvSpPr txBox="1"/>
            <p:nvPr/>
          </p:nvSpPr>
          <p:spPr>
            <a:xfrm>
              <a:off x="169461" y="2665401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/>
                <a:t>4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B449291-17BC-8701-0D67-083D7C0472BE}"/>
                </a:ext>
              </a:extLst>
            </p:cNvPr>
            <p:cNvSpPr txBox="1"/>
            <p:nvPr/>
          </p:nvSpPr>
          <p:spPr>
            <a:xfrm>
              <a:off x="167343" y="3040201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C735E20-A247-C64D-7D1E-F0354358483D}"/>
                </a:ext>
              </a:extLst>
            </p:cNvPr>
            <p:cNvSpPr txBox="1"/>
            <p:nvPr/>
          </p:nvSpPr>
          <p:spPr>
            <a:xfrm>
              <a:off x="157726" y="3421343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79D2C4A-D859-51FD-A037-CA9B4486B143}"/>
                </a:ext>
              </a:extLst>
            </p:cNvPr>
            <p:cNvSpPr txBox="1"/>
            <p:nvPr/>
          </p:nvSpPr>
          <p:spPr>
            <a:xfrm>
              <a:off x="4290310" y="877551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3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E27DA76-0CCC-3395-E7ED-B28C3B998033}"/>
                </a:ext>
              </a:extLst>
            </p:cNvPr>
            <p:cNvSpPr txBox="1"/>
            <p:nvPr/>
          </p:nvSpPr>
          <p:spPr>
            <a:xfrm>
              <a:off x="4290309" y="1292378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/>
                <a:t>2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FD8AD88-C25A-359E-AE66-D95E1FB21C2D}"/>
                </a:ext>
              </a:extLst>
            </p:cNvPr>
            <p:cNvSpPr txBox="1"/>
            <p:nvPr/>
          </p:nvSpPr>
          <p:spPr>
            <a:xfrm>
              <a:off x="4290308" y="1701817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1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6E03F74-5950-8FAA-5D88-1056011902F8}"/>
                </a:ext>
              </a:extLst>
            </p:cNvPr>
            <p:cNvSpPr txBox="1"/>
            <p:nvPr/>
          </p:nvSpPr>
          <p:spPr>
            <a:xfrm>
              <a:off x="4261751" y="2289463"/>
              <a:ext cx="3328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/>
                <a:t>1.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91BCE83-2790-1535-B8E4-71767D3D6E29}"/>
                </a:ext>
              </a:extLst>
            </p:cNvPr>
            <p:cNvSpPr txBox="1"/>
            <p:nvPr/>
          </p:nvSpPr>
          <p:spPr>
            <a:xfrm>
              <a:off x="4261751" y="2622650"/>
              <a:ext cx="3328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/>
                <a:t>1.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E2F3945-20CC-CE22-E842-969ADA9AFE73}"/>
                </a:ext>
              </a:extLst>
            </p:cNvPr>
            <p:cNvSpPr txBox="1"/>
            <p:nvPr/>
          </p:nvSpPr>
          <p:spPr>
            <a:xfrm>
              <a:off x="4261751" y="3018707"/>
              <a:ext cx="3328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/>
                <a:t>0.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145A4677-44F3-69A0-7A63-E298F16E9AA1}"/>
                </a:ext>
              </a:extLst>
            </p:cNvPr>
            <p:cNvSpPr txBox="1"/>
            <p:nvPr/>
          </p:nvSpPr>
          <p:spPr>
            <a:xfrm>
              <a:off x="4261751" y="3400399"/>
              <a:ext cx="3328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0.0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03E39D6B-CA02-897B-CF6B-EDD7A74B0E80}"/>
                </a:ext>
              </a:extLst>
            </p:cNvPr>
            <p:cNvSpPr txBox="1"/>
            <p:nvPr/>
          </p:nvSpPr>
          <p:spPr>
            <a:xfrm rot="16200000">
              <a:off x="2890658" y="2048070"/>
              <a:ext cx="276867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b="1"/>
              </a:lvl1pPr>
            </a:lstStyle>
            <a:p>
              <a:pPr algn="ctr"/>
              <a:r>
                <a:rPr lang="en-US" sz="800" b="0" dirty="0"/>
                <a:t>% of infiltrating cells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84584D3-D405-0657-3D02-F5F688AEC99C}"/>
                </a:ext>
              </a:extLst>
            </p:cNvPr>
            <p:cNvSpPr txBox="1"/>
            <p:nvPr/>
          </p:nvSpPr>
          <p:spPr>
            <a:xfrm>
              <a:off x="8232019" y="877551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60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ED2A967-3EDA-A8D2-18FD-A4BA9A2B97F1}"/>
                </a:ext>
              </a:extLst>
            </p:cNvPr>
            <p:cNvSpPr txBox="1"/>
            <p:nvPr/>
          </p:nvSpPr>
          <p:spPr>
            <a:xfrm>
              <a:off x="8234290" y="1277044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40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5C9FD1B-C806-30C8-2FF3-6AC463162571}"/>
                </a:ext>
              </a:extLst>
            </p:cNvPr>
            <p:cNvSpPr txBox="1"/>
            <p:nvPr/>
          </p:nvSpPr>
          <p:spPr>
            <a:xfrm>
              <a:off x="8239639" y="1681565"/>
              <a:ext cx="30432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2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762C516-282C-2392-7897-437450963607}"/>
                </a:ext>
              </a:extLst>
            </p:cNvPr>
            <p:cNvSpPr txBox="1"/>
            <p:nvPr/>
          </p:nvSpPr>
          <p:spPr>
            <a:xfrm>
              <a:off x="8218421" y="2272535"/>
              <a:ext cx="3683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1.0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459AD02-5C42-A692-15A7-0D491A7085C0}"/>
                </a:ext>
              </a:extLst>
            </p:cNvPr>
            <p:cNvSpPr txBox="1"/>
            <p:nvPr/>
          </p:nvSpPr>
          <p:spPr>
            <a:xfrm>
              <a:off x="8218422" y="2485772"/>
              <a:ext cx="3683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0.8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D2C946FF-8B02-7817-0551-A02B0165DC51}"/>
                </a:ext>
              </a:extLst>
            </p:cNvPr>
            <p:cNvSpPr txBox="1"/>
            <p:nvPr/>
          </p:nvSpPr>
          <p:spPr>
            <a:xfrm>
              <a:off x="8218421" y="2721948"/>
              <a:ext cx="3683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0.6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573E4BE-0CD9-E556-3610-8416530DB058}"/>
                </a:ext>
              </a:extLst>
            </p:cNvPr>
            <p:cNvSpPr txBox="1"/>
            <p:nvPr/>
          </p:nvSpPr>
          <p:spPr>
            <a:xfrm>
              <a:off x="8218421" y="2948297"/>
              <a:ext cx="3683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0.4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62BBFF18-AF68-2836-11E4-A99B6DBCB971}"/>
                </a:ext>
              </a:extLst>
            </p:cNvPr>
            <p:cNvSpPr txBox="1"/>
            <p:nvPr/>
          </p:nvSpPr>
          <p:spPr>
            <a:xfrm>
              <a:off x="8207643" y="3194343"/>
              <a:ext cx="3683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0.2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47FCF99F-44CF-79A4-B92E-1AE5887778B0}"/>
                </a:ext>
              </a:extLst>
            </p:cNvPr>
            <p:cNvSpPr txBox="1"/>
            <p:nvPr/>
          </p:nvSpPr>
          <p:spPr>
            <a:xfrm>
              <a:off x="8216779" y="3421343"/>
              <a:ext cx="3328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0.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0B573E8-3380-547A-29CA-63EB6D01B99A}"/>
                </a:ext>
              </a:extLst>
            </p:cNvPr>
            <p:cNvSpPr txBox="1"/>
            <p:nvPr/>
          </p:nvSpPr>
          <p:spPr>
            <a:xfrm rot="16200000">
              <a:off x="6764553" y="2058181"/>
              <a:ext cx="276867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b="1"/>
              </a:lvl1pPr>
            </a:lstStyle>
            <a:p>
              <a:pPr algn="ctr"/>
              <a:r>
                <a:rPr lang="en-US" sz="800" b="0" dirty="0"/>
                <a:t>% of infiltrating cell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70413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cc8b63ee-64cf-4a99-8987-95f8e0e257c5">
      <Terms xmlns="http://schemas.microsoft.com/office/infopath/2007/PartnerControls"/>
    </lcf76f155ced4ddcb4097134ff3c332f>
    <TaxCatchAll xmlns="7f4c377c-6705-4b4f-8b07-648fa1217e5d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48857253FD10B418DFFC8AF56E52813" ma:contentTypeVersion="15" ma:contentTypeDescription="Create a new document." ma:contentTypeScope="" ma:versionID="fd18f8ef797e431b951545bdf5cef5c4">
  <xsd:schema xmlns:xsd="http://www.w3.org/2001/XMLSchema" xmlns:xs="http://www.w3.org/2001/XMLSchema" xmlns:p="http://schemas.microsoft.com/office/2006/metadata/properties" xmlns:ns2="cc8b63ee-64cf-4a99-8987-95f8e0e257c5" xmlns:ns3="7f4c377c-6705-4b4f-8b07-648fa1217e5d" targetNamespace="http://schemas.microsoft.com/office/2006/metadata/properties" ma:root="true" ma:fieldsID="ac07ba9186dc7a755daa4e3822ed20dc" ns2:_="" ns3:_="">
    <xsd:import namespace="cc8b63ee-64cf-4a99-8987-95f8e0e257c5"/>
    <xsd:import namespace="7f4c377c-6705-4b4f-8b07-648fa1217e5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c8b63ee-64cf-4a99-8987-95f8e0e257c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Image Tags" ma:readOnly="false" ma:fieldId="{5cf76f15-5ced-4ddc-b409-7134ff3c332f}" ma:taxonomyMulti="true" ma:sspId="d898b932-ec87-4f6e-a380-e59be69e9f7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dexed="true" ma:internalName="MediaServiceLocation" ma:readOnly="true">
      <xsd:simpleType>
        <xsd:restriction base="dms:Text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f4c377c-6705-4b4f-8b07-648fa1217e5d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ce3bf326-c720-4233-acef-1ee9483f63f2}" ma:internalName="TaxCatchAll" ma:showField="CatchAllData" ma:web="7f4c377c-6705-4b4f-8b07-648fa1217e5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6CFB900-96D3-4FA7-8E2D-1D7D9C5D58B4}">
  <ds:schemaRefs>
    <ds:schemaRef ds:uri="http://purl.org/dc/elements/1.1/"/>
    <ds:schemaRef ds:uri="http://schemas.microsoft.com/office/infopath/2007/PartnerControls"/>
    <ds:schemaRef ds:uri="http://purl.org/dc/dcmitype/"/>
    <ds:schemaRef ds:uri="http://schemas.openxmlformats.org/package/2006/metadata/core-properties"/>
    <ds:schemaRef ds:uri="7f4c377c-6705-4b4f-8b07-648fa1217e5d"/>
    <ds:schemaRef ds:uri="http://schemas.microsoft.com/office/2006/documentManagement/types"/>
    <ds:schemaRef ds:uri="http://www.w3.org/XML/1998/namespace"/>
    <ds:schemaRef ds:uri="cc8b63ee-64cf-4a99-8987-95f8e0e257c5"/>
    <ds:schemaRef ds:uri="http://schemas.microsoft.com/office/2006/metadata/propertie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36E3EB80-DB94-471B-ACBE-6F24366FF3F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DD8A0CC-AB54-4A42-B412-E368951518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c8b63ee-64cf-4a99-8987-95f8e0e257c5"/>
    <ds:schemaRef ds:uri="7f4c377c-6705-4b4f-8b07-648fa1217e5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84</TotalTime>
  <Words>147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doza Valderrey, Alberto</dc:creator>
  <cp:lastModifiedBy>Mendoza Valderrey, Alberto</cp:lastModifiedBy>
  <cp:revision>21</cp:revision>
  <cp:lastPrinted>2024-02-12T22:19:05Z</cp:lastPrinted>
  <dcterms:created xsi:type="dcterms:W3CDTF">2024-02-01T22:54:34Z</dcterms:created>
  <dcterms:modified xsi:type="dcterms:W3CDTF">2024-02-29T18:51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48857253FD10B418DFFC8AF56E52813</vt:lpwstr>
  </property>
  <property fmtid="{D5CDD505-2E9C-101B-9397-08002B2CF9AE}" pid="3" name="MediaServiceImageTags">
    <vt:lpwstr/>
  </property>
</Properties>
</file>